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  <p:sldMasterId id="2147483692" r:id="rId5"/>
  </p:sldMasterIdLst>
  <p:notesMasterIdLst>
    <p:notesMasterId r:id="rId7"/>
  </p:notesMasterIdLst>
  <p:sldIdLst>
    <p:sldId id="174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0BE2211-34B6-47B7-87CB-5D05C74B0DF7}" v="2" dt="2022-07-29T13:42:37.364"/>
    <p1510:client id="{768054CD-4F2D-4448-AA73-83D325193A49}" v="16" dt="2022-07-21T17:45:50.750"/>
    <p1510:client id="{E2C30B83-09D7-43A4-A157-919278D163C3}" v="6" dt="2022-08-10T16:59:15.72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77" autoAdjust="0"/>
    <p:restoredTop sz="87280" autoAdjust="0"/>
  </p:normalViewPr>
  <p:slideViewPr>
    <p:cSldViewPr snapToGrid="0">
      <p:cViewPr varScale="1">
        <p:scale>
          <a:sx n="88" d="100"/>
          <a:sy n="88" d="100"/>
        </p:scale>
        <p:origin x="94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21" Type="http://schemas.microsoft.com/office/2015/10/relationships/revisionInfo" Target="revisionInfo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ableStyles" Target="tableStyles.xml"/><Relationship Id="rId5" Type="http://schemas.openxmlformats.org/officeDocument/2006/relationships/slideMaster" Target="slideMasters/slideMaster2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eena Haiderlab" userId="GM2wwshbDHmf3YmDcq2JGfCPDfVnb4wbpG61PAFJxmI=" providerId="None" clId="Web-{768054CD-4F2D-4448-AA73-83D325193A49}"/>
    <pc:docChg chg="modSld">
      <pc:chgData name="Neena Haiderlab" userId="GM2wwshbDHmf3YmDcq2JGfCPDfVnb4wbpG61PAFJxmI=" providerId="None" clId="Web-{768054CD-4F2D-4448-AA73-83D325193A49}" dt="2022-07-21T17:45:50.750" v="14" actId="1076"/>
      <pc:docMkLst>
        <pc:docMk/>
      </pc:docMkLst>
      <pc:sldChg chg="addSp delSp modSp">
        <pc:chgData name="Neena Haiderlab" userId="GM2wwshbDHmf3YmDcq2JGfCPDfVnb4wbpG61PAFJxmI=" providerId="None" clId="Web-{768054CD-4F2D-4448-AA73-83D325193A49}" dt="2022-07-21T17:45:50.750" v="14" actId="1076"/>
        <pc:sldMkLst>
          <pc:docMk/>
          <pc:sldMk cId="3735271789" sldId="1708"/>
        </pc:sldMkLst>
        <pc:spChg chg="del">
          <ac:chgData name="Neena Haiderlab" userId="GM2wwshbDHmf3YmDcq2JGfCPDfVnb4wbpG61PAFJxmI=" providerId="None" clId="Web-{768054CD-4F2D-4448-AA73-83D325193A49}" dt="2022-07-21T17:43:18.261" v="1"/>
          <ac:spMkLst>
            <pc:docMk/>
            <pc:sldMk cId="3735271789" sldId="1708"/>
            <ac:spMk id="40" creationId="{CE520BA5-CC52-8E76-1DE6-D641783F383B}"/>
          </ac:spMkLst>
        </pc:spChg>
        <pc:spChg chg="del">
          <ac:chgData name="Neena Haiderlab" userId="GM2wwshbDHmf3YmDcq2JGfCPDfVnb4wbpG61PAFJxmI=" providerId="None" clId="Web-{768054CD-4F2D-4448-AA73-83D325193A49}" dt="2022-07-21T17:45:16.187" v="7"/>
          <ac:spMkLst>
            <pc:docMk/>
            <pc:sldMk cId="3735271789" sldId="1708"/>
            <ac:spMk id="41" creationId="{ED1A54A6-8698-C146-CB2A-5614A2A25068}"/>
          </ac:spMkLst>
        </pc:spChg>
        <pc:spChg chg="del">
          <ac:chgData name="Neena Haiderlab" userId="GM2wwshbDHmf3YmDcq2JGfCPDfVnb4wbpG61PAFJxmI=" providerId="None" clId="Web-{768054CD-4F2D-4448-AA73-83D325193A49}" dt="2022-07-21T17:45:27.984" v="11"/>
          <ac:spMkLst>
            <pc:docMk/>
            <pc:sldMk cId="3735271789" sldId="1708"/>
            <ac:spMk id="42" creationId="{05744BAE-BA12-17B7-D793-7254DC17D5D0}"/>
          </ac:spMkLst>
        </pc:spChg>
        <pc:picChg chg="add mod">
          <ac:chgData name="Neena Haiderlab" userId="GM2wwshbDHmf3YmDcq2JGfCPDfVnb4wbpG61PAFJxmI=" providerId="None" clId="Web-{768054CD-4F2D-4448-AA73-83D325193A49}" dt="2022-07-21T17:43:36.465" v="5" actId="1076"/>
          <ac:picMkLst>
            <pc:docMk/>
            <pc:sldMk cId="3735271789" sldId="1708"/>
            <ac:picMk id="10" creationId="{D797830B-4E87-F80A-8801-20CEB0810554}"/>
          </ac:picMkLst>
        </pc:picChg>
        <pc:picChg chg="add mod">
          <ac:chgData name="Neena Haiderlab" userId="GM2wwshbDHmf3YmDcq2JGfCPDfVnb4wbpG61PAFJxmI=" providerId="None" clId="Web-{768054CD-4F2D-4448-AA73-83D325193A49}" dt="2022-07-21T17:45:25.468" v="10" actId="1076"/>
          <ac:picMkLst>
            <pc:docMk/>
            <pc:sldMk cId="3735271789" sldId="1708"/>
            <ac:picMk id="11" creationId="{487EEFA6-9E25-0FF4-213E-EBC763568DEC}"/>
          </ac:picMkLst>
        </pc:picChg>
        <pc:picChg chg="add mod">
          <ac:chgData name="Neena Haiderlab" userId="GM2wwshbDHmf3YmDcq2JGfCPDfVnb4wbpG61PAFJxmI=" providerId="None" clId="Web-{768054CD-4F2D-4448-AA73-83D325193A49}" dt="2022-07-21T17:45:50.750" v="14" actId="1076"/>
          <ac:picMkLst>
            <pc:docMk/>
            <pc:sldMk cId="3735271789" sldId="1708"/>
            <ac:picMk id="12" creationId="{1DC4ED28-BF8C-A636-7C98-46EFE3A3985E}"/>
          </ac:picMkLst>
        </pc:picChg>
      </pc:sldChg>
    </pc:docChg>
  </pc:docChgLst>
  <pc:docChgLst>
    <pc:chgData name="Neena Haiderlab" userId="GM2wwshbDHmf3YmDcq2JGfCPDfVnb4wbpG61PAFJxmI=" providerId="None" clId="Web-{E2C30B83-09D7-43A4-A157-919278D163C3}"/>
    <pc:docChg chg="modSld">
      <pc:chgData name="Neena Haiderlab" userId="GM2wwshbDHmf3YmDcq2JGfCPDfVnb4wbpG61PAFJxmI=" providerId="None" clId="Web-{E2C30B83-09D7-43A4-A157-919278D163C3}" dt="2022-08-10T16:59:13.021" v="1" actId="20577"/>
      <pc:docMkLst>
        <pc:docMk/>
      </pc:docMkLst>
      <pc:sldChg chg="modSp">
        <pc:chgData name="Neena Haiderlab" userId="GM2wwshbDHmf3YmDcq2JGfCPDfVnb4wbpG61PAFJxmI=" providerId="None" clId="Web-{E2C30B83-09D7-43A4-A157-919278D163C3}" dt="2022-08-10T16:59:13.021" v="1" actId="20577"/>
        <pc:sldMkLst>
          <pc:docMk/>
          <pc:sldMk cId="2250824817" sldId="1709"/>
        </pc:sldMkLst>
        <pc:spChg chg="mod">
          <ac:chgData name="Neena Haiderlab" userId="GM2wwshbDHmf3YmDcq2JGfCPDfVnb4wbpG61PAFJxmI=" providerId="None" clId="Web-{E2C30B83-09D7-43A4-A157-919278D163C3}" dt="2022-08-10T16:59:13.021" v="1" actId="20577"/>
          <ac:spMkLst>
            <pc:docMk/>
            <pc:sldMk cId="2250824817" sldId="1709"/>
            <ac:spMk id="8" creationId="{14903FB7-EC11-4374-9C8B-C20D20E9EE55}"/>
          </ac:spMkLst>
        </pc:spChg>
      </pc:sldChg>
    </pc:docChg>
  </pc:docChgLst>
  <pc:docChgLst>
    <pc:chgData name="Neena Haiderlab" userId="GM2wwshbDHmf3YmDcq2JGfCPDfVnb4wbpG61PAFJxmI=" providerId="None" clId="Web-{10BE2211-34B6-47B7-87CB-5D05C74B0DF7}"/>
    <pc:docChg chg="modSld">
      <pc:chgData name="Neena Haiderlab" userId="GM2wwshbDHmf3YmDcq2JGfCPDfVnb4wbpG61PAFJxmI=" providerId="None" clId="Web-{10BE2211-34B6-47B7-87CB-5D05C74B0DF7}" dt="2022-07-29T13:42:37.364" v="1" actId="1076"/>
      <pc:docMkLst>
        <pc:docMk/>
      </pc:docMkLst>
      <pc:sldChg chg="modSp">
        <pc:chgData name="Neena Haiderlab" userId="GM2wwshbDHmf3YmDcq2JGfCPDfVnb4wbpG61PAFJxmI=" providerId="None" clId="Web-{10BE2211-34B6-47B7-87CB-5D05C74B0DF7}" dt="2022-07-29T13:42:37.364" v="1" actId="1076"/>
        <pc:sldMkLst>
          <pc:docMk/>
          <pc:sldMk cId="3735271789" sldId="1708"/>
        </pc:sldMkLst>
        <pc:picChg chg="mod">
          <ac:chgData name="Neena Haiderlab" userId="GM2wwshbDHmf3YmDcq2JGfCPDfVnb4wbpG61PAFJxmI=" providerId="None" clId="Web-{10BE2211-34B6-47B7-87CB-5D05C74B0DF7}" dt="2022-07-29T13:42:37.364" v="1" actId="1076"/>
          <ac:picMkLst>
            <pc:docMk/>
            <pc:sldMk cId="3735271789" sldId="1708"/>
            <ac:picMk id="55" creationId="{D8BE9025-05D2-B782-3564-927BEC62CA8A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dirty="0"/>
              <a:t>Mean RORA Fluorescence Intensity in the </a:t>
            </a:r>
            <a:r>
              <a:rPr lang="en-US" sz="1200" dirty="0" smtClean="0"/>
              <a:t>RPE </a:t>
            </a:r>
            <a:r>
              <a:rPr lang="en-US" sz="1200" dirty="0"/>
              <a:t>in AAV5-</a:t>
            </a:r>
            <a:r>
              <a:rPr lang="en-US" sz="1200" i="1" dirty="0"/>
              <a:t>hRORA</a:t>
            </a:r>
            <a:r>
              <a:rPr lang="en-US" sz="1200" dirty="0"/>
              <a:t>-treated </a:t>
            </a:r>
            <a:r>
              <a:rPr lang="en-US" sz="1200" i="1" dirty="0"/>
              <a:t>Abca4</a:t>
            </a:r>
            <a:r>
              <a:rPr lang="en-US" sz="1200" i="1" baseline="30000" dirty="0"/>
              <a:t>-/-</a:t>
            </a:r>
            <a:r>
              <a:rPr lang="en-US" sz="1200" dirty="0"/>
              <a:t> Mic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pattFill prst="pct25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pattFill prst="pct60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6"/>
            <c:invertIfNegative val="0"/>
            <c:bubble3D val="0"/>
            <c:spPr>
              <a:pattFill prst="trellis">
                <a:fgClr>
                  <a:schemeClr val="tx1">
                    <a:lumMod val="65000"/>
                    <a:lumOff val="3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pattFill prst="pct25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8"/>
            <c:invertIfNegative val="0"/>
            <c:bubble3D val="0"/>
            <c:spPr>
              <a:pattFill prst="pct60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9"/>
            <c:invertIfNegative val="0"/>
            <c:bubble3D val="0"/>
            <c:spPr>
              <a:pattFill prst="trellis">
                <a:fgClr>
                  <a:schemeClr val="tx1">
                    <a:lumMod val="65000"/>
                    <a:lumOff val="3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RORA fluorescence'!$B$47:$K$47</c:f>
                <c:numCache>
                  <c:formatCode>General</c:formatCode>
                  <c:ptCount val="10"/>
                  <c:pt idx="0">
                    <c:v>1.63907558652418</c:v>
                  </c:pt>
                  <c:pt idx="1">
                    <c:v>1.0519901473292306</c:v>
                  </c:pt>
                  <c:pt idx="2">
                    <c:v>0.32771023641982766</c:v>
                  </c:pt>
                  <c:pt idx="3">
                    <c:v>0.51169896932354453</c:v>
                  </c:pt>
                  <c:pt idx="4">
                    <c:v>1.155795314008498</c:v>
                  </c:pt>
                  <c:pt idx="5">
                    <c:v>1.3090103186094444</c:v>
                  </c:pt>
                  <c:pt idx="6">
                    <c:v>1.764472563579268</c:v>
                  </c:pt>
                  <c:pt idx="7">
                    <c:v>0.61628328406991795</c:v>
                  </c:pt>
                  <c:pt idx="8">
                    <c:v>1.5619987154328911</c:v>
                  </c:pt>
                  <c:pt idx="9">
                    <c:v>1.2034814909644427</c:v>
                  </c:pt>
                </c:numCache>
              </c:numRef>
            </c:plus>
            <c:minus>
              <c:numRef>
                <c:f>'RORA fluorescence'!$B$47:$K$47</c:f>
                <c:numCache>
                  <c:formatCode>General</c:formatCode>
                  <c:ptCount val="10"/>
                  <c:pt idx="0">
                    <c:v>1.63907558652418</c:v>
                  </c:pt>
                  <c:pt idx="1">
                    <c:v>1.0519901473292306</c:v>
                  </c:pt>
                  <c:pt idx="2">
                    <c:v>0.32771023641982766</c:v>
                  </c:pt>
                  <c:pt idx="3">
                    <c:v>0.51169896932354453</c:v>
                  </c:pt>
                  <c:pt idx="4">
                    <c:v>1.155795314008498</c:v>
                  </c:pt>
                  <c:pt idx="5">
                    <c:v>1.3090103186094444</c:v>
                  </c:pt>
                  <c:pt idx="6">
                    <c:v>1.764472563579268</c:v>
                  </c:pt>
                  <c:pt idx="7">
                    <c:v>0.61628328406991795</c:v>
                  </c:pt>
                  <c:pt idx="8">
                    <c:v>1.5619987154328911</c:v>
                  </c:pt>
                  <c:pt idx="9">
                    <c:v>1.20348149096444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RORA fluorescence'!$B$44:$K$45</c:f>
              <c:multiLvlStrCache>
                <c:ptCount val="10"/>
                <c:lvl>
                  <c:pt idx="0">
                    <c:v>4M</c:v>
                  </c:pt>
                  <c:pt idx="1">
                    <c:v>7M</c:v>
                  </c:pt>
                  <c:pt idx="2">
                    <c:v>4M</c:v>
                  </c:pt>
                  <c:pt idx="3">
                    <c:v>7M</c:v>
                  </c:pt>
                  <c:pt idx="4">
                    <c:v>4M Low Dose</c:v>
                  </c:pt>
                  <c:pt idx="5">
                    <c:v>4M Mid Dose</c:v>
                  </c:pt>
                  <c:pt idx="6">
                    <c:v>4M High Dose</c:v>
                  </c:pt>
                  <c:pt idx="7">
                    <c:v>7M Low Dose</c:v>
                  </c:pt>
                  <c:pt idx="8">
                    <c:v>7M Mid Dose</c:v>
                  </c:pt>
                  <c:pt idx="9">
                    <c:v>7M High Dose</c:v>
                  </c:pt>
                </c:lvl>
                <c:lvl>
                  <c:pt idx="0">
                    <c:v>129S1 WT</c:v>
                  </c:pt>
                  <c:pt idx="2">
                    <c:v>Untreated</c:v>
                  </c:pt>
                  <c:pt idx="4">
                    <c:v>AAV5-hRORA-treated</c:v>
                  </c:pt>
                </c:lvl>
              </c:multiLvlStrCache>
            </c:multiLvlStrRef>
          </c:cat>
          <c:val>
            <c:numRef>
              <c:f>'RORA fluorescence'!$B$46:$K$46</c:f>
              <c:numCache>
                <c:formatCode>General</c:formatCode>
                <c:ptCount val="10"/>
                <c:pt idx="0">
                  <c:v>6.0000324999999997</c:v>
                </c:pt>
                <c:pt idx="1">
                  <c:v>6.9499166666666667</c:v>
                </c:pt>
                <c:pt idx="2">
                  <c:v>2.0313869230769228</c:v>
                </c:pt>
                <c:pt idx="3">
                  <c:v>2.3885429999999999</c:v>
                </c:pt>
                <c:pt idx="4">
                  <c:v>6.6818280000000003</c:v>
                </c:pt>
                <c:pt idx="5">
                  <c:v>7.1801339999999998</c:v>
                </c:pt>
                <c:pt idx="6">
                  <c:v>8.0858880000000006</c:v>
                </c:pt>
                <c:pt idx="7">
                  <c:v>7.1332179999999994</c:v>
                </c:pt>
                <c:pt idx="8">
                  <c:v>7.5293679999999998</c:v>
                </c:pt>
                <c:pt idx="9">
                  <c:v>8.559722000000000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49968128"/>
        <c:axId val="-2144828384"/>
      </c:barChart>
      <c:catAx>
        <c:axId val="-49968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44828384"/>
        <c:crosses val="autoZero"/>
        <c:auto val="1"/>
        <c:lblAlgn val="ctr"/>
        <c:lblOffset val="100"/>
        <c:noMultiLvlLbl val="0"/>
      </c:catAx>
      <c:valAx>
        <c:axId val="-21448283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b="0" i="0" baseline="0">
                    <a:effectLst/>
                  </a:rPr>
                  <a:t>Mean RORA Fluorescence Intensity</a:t>
                </a:r>
                <a:endParaRPr lang="en-US" sz="1000">
                  <a:effectLst/>
                </a:endParaRPr>
              </a:p>
            </c:rich>
          </c:tx>
          <c:layout>
            <c:manualLayout>
              <c:xMode val="edge"/>
              <c:yMode val="edge"/>
              <c:x val="2.7633295292222099E-2"/>
              <c:y val="0.1618056288883964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49968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200" dirty="0"/>
              <a:t>Mean </a:t>
            </a:r>
            <a:r>
              <a:rPr lang="en-US" sz="1200" dirty="0" smtClean="0"/>
              <a:t>RORA Fluorescence </a:t>
            </a:r>
            <a:r>
              <a:rPr lang="en-US" sz="1200" dirty="0"/>
              <a:t>Intensity </a:t>
            </a:r>
            <a:r>
              <a:rPr lang="en-US" sz="1200" dirty="0" smtClean="0"/>
              <a:t>in </a:t>
            </a:r>
            <a:r>
              <a:rPr lang="en-US" sz="1200" dirty="0"/>
              <a:t>the Photoreceptor IS/OS </a:t>
            </a:r>
            <a:r>
              <a:rPr lang="en-US" sz="1200" dirty="0" smtClean="0"/>
              <a:t>in </a:t>
            </a:r>
            <a:r>
              <a:rPr lang="en-US" sz="1200" dirty="0"/>
              <a:t>AAV5-</a:t>
            </a:r>
            <a:r>
              <a:rPr lang="en-US" sz="1200" i="1" dirty="0"/>
              <a:t>hRORA</a:t>
            </a:r>
            <a:r>
              <a:rPr lang="en-US" sz="1200" dirty="0"/>
              <a:t>-treated </a:t>
            </a:r>
            <a:r>
              <a:rPr lang="en-US" sz="1200" i="1" dirty="0"/>
              <a:t>Abca4</a:t>
            </a:r>
            <a:r>
              <a:rPr lang="en-US" sz="1200" i="1" baseline="30000" dirty="0"/>
              <a:t>-/-</a:t>
            </a:r>
            <a:r>
              <a:rPr lang="en-US" sz="1200" dirty="0"/>
              <a:t> Mic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4"/>
            <c:invertIfNegative val="0"/>
            <c:bubble3D val="0"/>
            <c:spPr>
              <a:pattFill prst="pct25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pattFill prst="pct60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6"/>
            <c:invertIfNegative val="0"/>
            <c:bubble3D val="0"/>
            <c:spPr>
              <a:pattFill prst="trellis">
                <a:fgClr>
                  <a:schemeClr val="tx1">
                    <a:lumMod val="65000"/>
                    <a:lumOff val="3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pattFill prst="pct25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8"/>
            <c:invertIfNegative val="0"/>
            <c:bubble3D val="0"/>
            <c:spPr>
              <a:pattFill prst="pct60">
                <a:fgClr>
                  <a:schemeClr val="bg1">
                    <a:lumMod val="5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dPt>
            <c:idx val="9"/>
            <c:invertIfNegative val="0"/>
            <c:bubble3D val="0"/>
            <c:spPr>
              <a:pattFill prst="trellis">
                <a:fgClr>
                  <a:schemeClr val="tx1">
                    <a:lumMod val="65000"/>
                    <a:lumOff val="35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'RORA fluorescence'!$B$41:$K$41</c:f>
                <c:numCache>
                  <c:formatCode>General</c:formatCode>
                  <c:ptCount val="10"/>
                  <c:pt idx="0">
                    <c:v>2.5909737587721748</c:v>
                  </c:pt>
                  <c:pt idx="1">
                    <c:v>5.1214596178111167</c:v>
                  </c:pt>
                  <c:pt idx="2">
                    <c:v>1.3235616185270584</c:v>
                  </c:pt>
                  <c:pt idx="3">
                    <c:v>1.2955341694114413</c:v>
                  </c:pt>
                  <c:pt idx="4">
                    <c:v>2.9294631324299023</c:v>
                  </c:pt>
                  <c:pt idx="5">
                    <c:v>1.7787678730222141</c:v>
                  </c:pt>
                  <c:pt idx="6">
                    <c:v>1.0693005873438957</c:v>
                  </c:pt>
                  <c:pt idx="7">
                    <c:v>2.0515441478296319</c:v>
                  </c:pt>
                  <c:pt idx="8">
                    <c:v>2.4491095975897044</c:v>
                  </c:pt>
                  <c:pt idx="9">
                    <c:v>3.1115063947168595</c:v>
                  </c:pt>
                </c:numCache>
              </c:numRef>
            </c:plus>
            <c:minus>
              <c:numRef>
                <c:f>'RORA fluorescence'!$B$41:$K$41</c:f>
                <c:numCache>
                  <c:formatCode>General</c:formatCode>
                  <c:ptCount val="10"/>
                  <c:pt idx="0">
                    <c:v>2.5909737587721748</c:v>
                  </c:pt>
                  <c:pt idx="1">
                    <c:v>5.1214596178111167</c:v>
                  </c:pt>
                  <c:pt idx="2">
                    <c:v>1.3235616185270584</c:v>
                  </c:pt>
                  <c:pt idx="3">
                    <c:v>1.2955341694114413</c:v>
                  </c:pt>
                  <c:pt idx="4">
                    <c:v>2.9294631324299023</c:v>
                  </c:pt>
                  <c:pt idx="5">
                    <c:v>1.7787678730222141</c:v>
                  </c:pt>
                  <c:pt idx="6">
                    <c:v>1.0693005873438957</c:v>
                  </c:pt>
                  <c:pt idx="7">
                    <c:v>2.0515441478296319</c:v>
                  </c:pt>
                  <c:pt idx="8">
                    <c:v>2.4491095975897044</c:v>
                  </c:pt>
                  <c:pt idx="9">
                    <c:v>3.11150639471685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RORA fluorescence'!$B$38:$K$39</c:f>
              <c:multiLvlStrCache>
                <c:ptCount val="10"/>
                <c:lvl>
                  <c:pt idx="0">
                    <c:v>4M</c:v>
                  </c:pt>
                  <c:pt idx="1">
                    <c:v>7M</c:v>
                  </c:pt>
                  <c:pt idx="2">
                    <c:v>4M</c:v>
                  </c:pt>
                  <c:pt idx="3">
                    <c:v>7M</c:v>
                  </c:pt>
                  <c:pt idx="4">
                    <c:v>4M Low Dose</c:v>
                  </c:pt>
                  <c:pt idx="5">
                    <c:v>4M Mid Dose</c:v>
                  </c:pt>
                  <c:pt idx="6">
                    <c:v>4M High Dose</c:v>
                  </c:pt>
                  <c:pt idx="7">
                    <c:v>7M Low Dose</c:v>
                  </c:pt>
                  <c:pt idx="8">
                    <c:v>7M Mid Dose</c:v>
                  </c:pt>
                  <c:pt idx="9">
                    <c:v>7M High Dose</c:v>
                  </c:pt>
                </c:lvl>
                <c:lvl>
                  <c:pt idx="0">
                    <c:v>129S1 WT</c:v>
                  </c:pt>
                  <c:pt idx="2">
                    <c:v>Untreated</c:v>
                  </c:pt>
                  <c:pt idx="4">
                    <c:v>AAV5-hRORA-treated</c:v>
                  </c:pt>
                </c:lvl>
              </c:multiLvlStrCache>
            </c:multiLvlStrRef>
          </c:cat>
          <c:val>
            <c:numRef>
              <c:f>'RORA fluorescence'!$B$40:$K$40</c:f>
              <c:numCache>
                <c:formatCode>General</c:formatCode>
                <c:ptCount val="10"/>
                <c:pt idx="0">
                  <c:v>23.517513999999998</c:v>
                </c:pt>
                <c:pt idx="1">
                  <c:v>21.603379999999998</c:v>
                </c:pt>
                <c:pt idx="2">
                  <c:v>13.152541333333334</c:v>
                </c:pt>
                <c:pt idx="3">
                  <c:v>10.674100714285716</c:v>
                </c:pt>
                <c:pt idx="4">
                  <c:v>24.562214000000001</c:v>
                </c:pt>
                <c:pt idx="5">
                  <c:v>25.917124000000001</c:v>
                </c:pt>
                <c:pt idx="6">
                  <c:v>28.291592000000001</c:v>
                </c:pt>
                <c:pt idx="7">
                  <c:v>19.248058</c:v>
                </c:pt>
                <c:pt idx="8">
                  <c:v>29.262983999999999</c:v>
                </c:pt>
                <c:pt idx="9">
                  <c:v>30.042558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44841984"/>
        <c:axId val="-2144838176"/>
      </c:barChart>
      <c:catAx>
        <c:axId val="-21448419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44838176"/>
        <c:crosses val="autoZero"/>
        <c:auto val="1"/>
        <c:lblAlgn val="ctr"/>
        <c:lblOffset val="100"/>
        <c:noMultiLvlLbl val="0"/>
      </c:catAx>
      <c:valAx>
        <c:axId val="-21448381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smtClean="0"/>
                  <a:t>Mean RORA Fluorescence Intensity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2.2253481365386393E-2"/>
              <c:y val="0.1622891435926272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44841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8DA5E5-EFA4-404A-ACBB-2A09D0FA223E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FDFFA4-81C0-4E05-84F1-7B97A5D83F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5081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2FDFFA4-81C0-4E05-84F1-7B97A5D83FC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4303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lide Number Placeholder 4"/>
          <p:cNvSpPr txBox="1">
            <a:spLocks/>
          </p:cNvSpPr>
          <p:nvPr userDrawn="1"/>
        </p:nvSpPr>
        <p:spPr>
          <a:xfrm>
            <a:off x="11035460" y="6370621"/>
            <a:ext cx="507360" cy="362292"/>
          </a:xfrm>
          <a:prstGeom prst="rect">
            <a:avLst/>
          </a:prstGeom>
        </p:spPr>
        <p:txBody>
          <a:bodyPr vert="horz" lIns="121920" tIns="60960" rIns="121920" bIns="60960" rtlCol="0" anchor="ctr"/>
          <a:lstStyle>
            <a:lvl1pPr algn="ct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1219107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F6AEBD56-55D3-48E2-AF3D-98EA3AFFDD08}" type="slidenum">
              <a:rPr kumimoji="0" lang="en-US" sz="1333" b="1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75000"/>
                    <a:lumOff val="25000"/>
                  </a:prstClr>
                </a:solidFill>
                <a:effectLst/>
                <a:uLnTx/>
                <a:uFillTx/>
                <a:latin typeface="Calibri"/>
                <a:ea typeface="+mn-ea"/>
                <a:cs typeface="Calibri"/>
              </a:rPr>
              <a:pPr marL="0" marR="0" lvl="0" indent="0" algn="ctr" defTabSz="1219107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r>
              <a:rPr kumimoji="0" lang="en-US" sz="1600" b="1" i="0" u="none" strike="noStrike" kern="1200" cap="none" spc="0" normalizeH="0" baseline="0" noProof="0">
                <a:ln>
                  <a:noFill/>
                </a:ln>
                <a:solidFill>
                  <a:srgbClr val="AAA27C"/>
                </a:solidFill>
                <a:effectLst/>
                <a:uLnTx/>
                <a:uFillTx/>
                <a:latin typeface="Calibri"/>
                <a:ea typeface="+mn-ea"/>
                <a:cs typeface="Calibri"/>
              </a:rPr>
              <a:t> </a:t>
            </a:r>
          </a:p>
        </p:txBody>
      </p:sp>
      <p:sp>
        <p:nvSpPr>
          <p:cNvPr id="12" name="Title 11"/>
          <p:cNvSpPr>
            <a:spLocks noGrp="1"/>
          </p:cNvSpPr>
          <p:nvPr>
            <p:ph type="title" hasCustomPrompt="1"/>
          </p:nvPr>
        </p:nvSpPr>
        <p:spPr>
          <a:xfrm>
            <a:off x="306332" y="89815"/>
            <a:ext cx="9651139" cy="707886"/>
          </a:xfrm>
          <a:prstGeom prst="rect">
            <a:avLst/>
          </a:prstGeom>
        </p:spPr>
        <p:txBody>
          <a:bodyPr vert="horz" wrap="square">
            <a:spAutoFit/>
          </a:bodyPr>
          <a:lstStyle>
            <a:lvl1pPr algn="l">
              <a:defRPr sz="4000" b="1" baseline="0">
                <a:solidFill>
                  <a:schemeClr val="bg1"/>
                </a:solidFill>
                <a:latin typeface="Calibri Light"/>
                <a:cs typeface="Calibri Light"/>
              </a:defRPr>
            </a:lvl1pPr>
          </a:lstStyle>
          <a:p>
            <a:r>
              <a:rPr lang="en-US"/>
              <a:t>Click Here to Change Headline</a:t>
            </a:r>
          </a:p>
        </p:txBody>
      </p:sp>
      <p:pic>
        <p:nvPicPr>
          <p:cNvPr id="4" name="Picture 3"/>
          <p:cNvPicPr>
            <a:picLocks noChangeAspect="1" noChangeArrowheads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-8075" y="5845699"/>
            <a:ext cx="12192000" cy="1012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 userDrawn="1"/>
        </p:nvSpPr>
        <p:spPr>
          <a:xfrm>
            <a:off x="1897431" y="6410322"/>
            <a:ext cx="6242792" cy="2358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609553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33" b="1" i="0" u="none" strike="noStrike" kern="1200" cap="none" spc="0" normalizeH="0" baseline="0" noProof="0">
                <a:ln>
                  <a:noFill/>
                </a:ln>
                <a:solidFill>
                  <a:prstClr val="black">
                    <a:lumMod val="50000"/>
                    <a:lumOff val="50000"/>
                  </a:prstClr>
                </a:solidFill>
                <a:effectLst/>
                <a:uLnTx/>
                <a:uFillTx/>
                <a:latin typeface="Calibri Light" panose="020F0302020204030204" pitchFamily="34" charset="0"/>
                <a:ea typeface="+mn-ea"/>
                <a:cs typeface="+mn-cs"/>
              </a:rPr>
              <a:t>©2021  Ocugen. All Rights Reserved.</a:t>
            </a:r>
          </a:p>
        </p:txBody>
      </p:sp>
      <p:sp>
        <p:nvSpPr>
          <p:cNvPr id="6" name="Slide Number Placeholder 4">
            <a:extLst>
              <a:ext uri="{FF2B5EF4-FFF2-40B4-BE49-F238E27FC236}">
                <a16:creationId xmlns:a16="http://schemas.microsoft.com/office/drawing/2014/main" xmlns="" id="{84859840-464D-4F3F-8D34-BC997913A1F5}"/>
              </a:ext>
            </a:extLst>
          </p:cNvPr>
          <p:cNvSpPr txBox="1">
            <a:spLocks/>
          </p:cNvSpPr>
          <p:nvPr userDrawn="1"/>
        </p:nvSpPr>
        <p:spPr>
          <a:xfrm>
            <a:off x="11035460" y="6351849"/>
            <a:ext cx="507360" cy="362292"/>
          </a:xfrm>
          <a:prstGeom prst="rect">
            <a:avLst/>
          </a:prstGeom>
        </p:spPr>
        <p:txBody>
          <a:bodyPr vert="horz" lIns="121920" tIns="60960" rIns="121920" bIns="60960" rtlCol="0" anchor="ctr"/>
          <a:lstStyle>
            <a:lvl1pPr algn="ctr">
              <a:defRPr sz="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1219107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F6AEBD56-55D3-48E2-AF3D-98EA3AFFDD08}" type="slidenum">
              <a:rPr kumimoji="0" lang="en-US" sz="1333" b="1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lumMod val="75000"/>
                    <a:lumOff val="25000"/>
                  </a:prstClr>
                </a:solidFill>
                <a:effectLst/>
                <a:uLnTx/>
                <a:uFillTx/>
                <a:latin typeface="Calibri"/>
                <a:ea typeface="+mn-ea"/>
                <a:cs typeface="Calibri"/>
              </a:rPr>
              <a:pPr marL="0" marR="0" lvl="0" indent="0" algn="ctr" defTabSz="1219107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r>
              <a:rPr kumimoji="0" lang="en-US" sz="1600" b="1" i="0" u="none" strike="noStrike" kern="1200" cap="none" spc="0" normalizeH="0" baseline="0" noProof="0">
                <a:ln>
                  <a:noFill/>
                </a:ln>
                <a:solidFill>
                  <a:prstClr val="black">
                    <a:lumMod val="75000"/>
                    <a:lumOff val="25000"/>
                  </a:prstClr>
                </a:solidFill>
                <a:effectLst/>
                <a:uLnTx/>
                <a:uFillTx/>
                <a:latin typeface="Calibri"/>
                <a:ea typeface="+mn-ea"/>
                <a:cs typeface="Calibri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262214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8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77" indent="0">
              <a:buNone/>
              <a:defRPr sz="2800"/>
            </a:lvl2pPr>
            <a:lvl3pPr marL="914352" indent="0">
              <a:buNone/>
              <a:defRPr sz="2400"/>
            </a:lvl3pPr>
            <a:lvl4pPr marL="1371528" indent="0">
              <a:buNone/>
              <a:defRPr sz="2000"/>
            </a:lvl4pPr>
            <a:lvl5pPr marL="1828705" indent="0">
              <a:buNone/>
              <a:defRPr sz="2000"/>
            </a:lvl5pPr>
            <a:lvl6pPr marL="2285882" indent="0">
              <a:buNone/>
              <a:defRPr sz="2000"/>
            </a:lvl6pPr>
            <a:lvl7pPr marL="2743057" indent="0">
              <a:buNone/>
              <a:defRPr sz="2000"/>
            </a:lvl7pPr>
            <a:lvl8pPr marL="3200232" indent="0">
              <a:buNone/>
              <a:defRPr sz="2000"/>
            </a:lvl8pPr>
            <a:lvl9pPr marL="3657407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057401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77" indent="0">
              <a:buNone/>
              <a:defRPr sz="1400"/>
            </a:lvl2pPr>
            <a:lvl3pPr marL="914352" indent="0">
              <a:buNone/>
              <a:defRPr sz="1200"/>
            </a:lvl3pPr>
            <a:lvl4pPr marL="1371528" indent="0">
              <a:buNone/>
              <a:defRPr sz="1000"/>
            </a:lvl4pPr>
            <a:lvl5pPr marL="1828705" indent="0">
              <a:buNone/>
              <a:defRPr sz="1000"/>
            </a:lvl5pPr>
            <a:lvl6pPr marL="2285882" indent="0">
              <a:buNone/>
              <a:defRPr sz="1000"/>
            </a:lvl6pPr>
            <a:lvl7pPr marL="2743057" indent="0">
              <a:buNone/>
              <a:defRPr sz="1000"/>
            </a:lvl7pPr>
            <a:lvl8pPr marL="3200232" indent="0">
              <a:buNone/>
              <a:defRPr sz="1000"/>
            </a:lvl8pPr>
            <a:lvl9pPr marL="3657407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6048-0273-4B64-AF16-29731839DA8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0B189-B85B-402A-919F-E5C5D8245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465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6048-0273-4B64-AF16-29731839DA8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0B189-B85B-402A-919F-E5C5D8245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8488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6048-0273-4B64-AF16-29731839DA8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0B189-B85B-402A-919F-E5C5D8245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708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77" indent="0" algn="ctr">
              <a:buNone/>
              <a:defRPr sz="2000"/>
            </a:lvl2pPr>
            <a:lvl3pPr marL="914352" indent="0" algn="ctr">
              <a:buNone/>
              <a:defRPr sz="1800"/>
            </a:lvl3pPr>
            <a:lvl4pPr marL="1371528" indent="0" algn="ctr">
              <a:buNone/>
              <a:defRPr sz="1600"/>
            </a:lvl4pPr>
            <a:lvl5pPr marL="1828705" indent="0" algn="ctr">
              <a:buNone/>
              <a:defRPr sz="1600"/>
            </a:lvl5pPr>
            <a:lvl6pPr marL="2285882" indent="0" algn="ctr">
              <a:buNone/>
              <a:defRPr sz="1600"/>
            </a:lvl6pPr>
            <a:lvl7pPr marL="2743057" indent="0" algn="ctr">
              <a:buNone/>
              <a:defRPr sz="1600"/>
            </a:lvl7pPr>
            <a:lvl8pPr marL="3200232" indent="0" algn="ctr">
              <a:buNone/>
              <a:defRPr sz="1600"/>
            </a:lvl8pPr>
            <a:lvl9pPr marL="3657407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6048-0273-4B64-AF16-29731839DA8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0B189-B85B-402A-919F-E5C5D8245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00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6048-0273-4B64-AF16-29731839DA8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0B189-B85B-402A-919F-E5C5D8245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531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1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6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77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5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2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0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88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5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0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6048-0273-4B64-AF16-29731839DA8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0B189-B85B-402A-919F-E5C5D8245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099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6048-0273-4B64-AF16-29731839DA8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0B189-B85B-402A-919F-E5C5D8245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556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8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1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7" indent="0">
              <a:buNone/>
              <a:defRPr sz="2000" b="1"/>
            </a:lvl2pPr>
            <a:lvl3pPr marL="914352" indent="0">
              <a:buNone/>
              <a:defRPr sz="1800" b="1"/>
            </a:lvl3pPr>
            <a:lvl4pPr marL="1371528" indent="0">
              <a:buNone/>
              <a:defRPr sz="1600" b="1"/>
            </a:lvl4pPr>
            <a:lvl5pPr marL="1828705" indent="0">
              <a:buNone/>
              <a:defRPr sz="1600" b="1"/>
            </a:lvl5pPr>
            <a:lvl6pPr marL="2285882" indent="0">
              <a:buNone/>
              <a:defRPr sz="1600" b="1"/>
            </a:lvl6pPr>
            <a:lvl7pPr marL="2743057" indent="0">
              <a:buNone/>
              <a:defRPr sz="1600" b="1"/>
            </a:lvl7pPr>
            <a:lvl8pPr marL="3200232" indent="0">
              <a:buNone/>
              <a:defRPr sz="1600" b="1"/>
            </a:lvl8pPr>
            <a:lvl9pPr marL="3657407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1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77" indent="0">
              <a:buNone/>
              <a:defRPr sz="2000" b="1"/>
            </a:lvl2pPr>
            <a:lvl3pPr marL="914352" indent="0">
              <a:buNone/>
              <a:defRPr sz="1800" b="1"/>
            </a:lvl3pPr>
            <a:lvl4pPr marL="1371528" indent="0">
              <a:buNone/>
              <a:defRPr sz="1600" b="1"/>
            </a:lvl4pPr>
            <a:lvl5pPr marL="1828705" indent="0">
              <a:buNone/>
              <a:defRPr sz="1600" b="1"/>
            </a:lvl5pPr>
            <a:lvl6pPr marL="2285882" indent="0">
              <a:buNone/>
              <a:defRPr sz="1600" b="1"/>
            </a:lvl6pPr>
            <a:lvl7pPr marL="2743057" indent="0">
              <a:buNone/>
              <a:defRPr sz="1600" b="1"/>
            </a:lvl7pPr>
            <a:lvl8pPr marL="3200232" indent="0">
              <a:buNone/>
              <a:defRPr sz="1600" b="1"/>
            </a:lvl8pPr>
            <a:lvl9pPr marL="3657407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6048-0273-4B64-AF16-29731839DA8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0B189-B85B-402A-919F-E5C5D8245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798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6048-0273-4B64-AF16-29731839DA8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0B189-B85B-402A-919F-E5C5D8245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021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6048-0273-4B64-AF16-29731839DA8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0B189-B85B-402A-919F-E5C5D8245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013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8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057401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77" indent="0">
              <a:buNone/>
              <a:defRPr sz="1400"/>
            </a:lvl2pPr>
            <a:lvl3pPr marL="914352" indent="0">
              <a:buNone/>
              <a:defRPr sz="1200"/>
            </a:lvl3pPr>
            <a:lvl4pPr marL="1371528" indent="0">
              <a:buNone/>
              <a:defRPr sz="1000"/>
            </a:lvl4pPr>
            <a:lvl5pPr marL="1828705" indent="0">
              <a:buNone/>
              <a:defRPr sz="1000"/>
            </a:lvl5pPr>
            <a:lvl6pPr marL="2285882" indent="0">
              <a:buNone/>
              <a:defRPr sz="1000"/>
            </a:lvl6pPr>
            <a:lvl7pPr marL="2743057" indent="0">
              <a:buNone/>
              <a:defRPr sz="1000"/>
            </a:lvl7pPr>
            <a:lvl8pPr marL="3200232" indent="0">
              <a:buNone/>
              <a:defRPr sz="1000"/>
            </a:lvl8pPr>
            <a:lvl9pPr marL="3657407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B6048-0273-4B64-AF16-29731839DA8F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0B189-B85B-402A-919F-E5C5D8245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738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9.xml"/><Relationship Id="rId3" Type="http://schemas.openxmlformats.org/officeDocument/2006/relationships/slideLayout" Target="../slideLayouts/slideLayout4.xml"/><Relationship Id="rId7" Type="http://schemas.openxmlformats.org/officeDocument/2006/relationships/slideLayout" Target="../slideLayouts/slideLayout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2.xml"/><Relationship Id="rId5" Type="http://schemas.openxmlformats.org/officeDocument/2006/relationships/slideLayout" Target="../slideLayouts/slideLayout6.xml"/><Relationship Id="rId10" Type="http://schemas.openxmlformats.org/officeDocument/2006/relationships/slideLayout" Target="../slideLayouts/slideLayout11.xml"/><Relationship Id="rId4" Type="http://schemas.openxmlformats.org/officeDocument/2006/relationships/slideLayout" Target="../slideLayouts/slideLayout5.xml"/><Relationship Id="rId9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template-inside-1.png"/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" y="0"/>
            <a:ext cx="12181172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0299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ctr" defTabSz="609553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65" indent="-457165" algn="l" defTabSz="609553" rtl="0" eaLnBrk="1" latinLnBrk="0" hangingPunct="1">
        <a:spcBef>
          <a:spcPct val="20000"/>
        </a:spcBef>
        <a:buFont typeface="Arial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23" indent="-380969" algn="l" defTabSz="609553" rtl="0" eaLnBrk="1" latinLnBrk="0" hangingPunct="1">
        <a:spcBef>
          <a:spcPct val="20000"/>
        </a:spcBef>
        <a:buFont typeface="Arial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882" indent="-304776" algn="l" defTabSz="609553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436" indent="-304776" algn="l" defTabSz="609553" rtl="0" eaLnBrk="1" latinLnBrk="0" hangingPunct="1">
        <a:spcBef>
          <a:spcPct val="20000"/>
        </a:spcBef>
        <a:buFont typeface="Arial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2987" indent="-304776" algn="l" defTabSz="609553" rtl="0" eaLnBrk="1" latinLnBrk="0" hangingPunct="1">
        <a:spcBef>
          <a:spcPct val="20000"/>
        </a:spcBef>
        <a:buFont typeface="Arial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540" indent="-304776" algn="l" defTabSz="609553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094" indent="-304776" algn="l" defTabSz="609553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647" indent="-304776" algn="l" defTabSz="609553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198" indent="-304776" algn="l" defTabSz="609553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55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53" algn="l" defTabSz="60955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07" algn="l" defTabSz="60955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658" algn="l" defTabSz="60955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211" algn="l" defTabSz="60955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765" algn="l" defTabSz="60955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318" algn="l" defTabSz="60955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6869" algn="l" defTabSz="60955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423" algn="l" defTabSz="609553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8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8A163-816E-4511-966B-FDA1DD0F0AC5}" type="datetimeFigureOut">
              <a:rPr lang="en-CA" smtClean="0"/>
              <a:t>2024-05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2B464B-4E63-4B40-937B-AE290FB4384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98604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3" r:id="rId1"/>
    <p:sldLayoutId id="2147483694" r:id="rId2"/>
    <p:sldLayoutId id="2147483695" r:id="rId3"/>
    <p:sldLayoutId id="2147483696" r:id="rId4"/>
    <p:sldLayoutId id="2147483697" r:id="rId5"/>
    <p:sldLayoutId id="2147483698" r:id="rId6"/>
    <p:sldLayoutId id="2147483699" r:id="rId7"/>
    <p:sldLayoutId id="2147483700" r:id="rId8"/>
    <p:sldLayoutId id="2147483701" r:id="rId9"/>
    <p:sldLayoutId id="2147483702" r:id="rId10"/>
    <p:sldLayoutId id="2147483703" r:id="rId11"/>
  </p:sldLayoutIdLst>
  <p:txStyles>
    <p:titleStyle>
      <a:lvl1pPr algn="l" defTabSz="914352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89" indent="-228589" algn="l" defTabSz="914352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64" indent="-228589" algn="l" defTabSz="91435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41" indent="-228589" algn="l" defTabSz="91435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16" indent="-228589" algn="l" defTabSz="91435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93" indent="-228589" algn="l" defTabSz="91435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68" indent="-228589" algn="l" defTabSz="91435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44" indent="-228589" algn="l" defTabSz="91435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21" indent="-228589" algn="l" defTabSz="91435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996" indent="-228589" algn="l" defTabSz="914352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77" algn="l" defTabSz="9143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52" algn="l" defTabSz="9143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28" algn="l" defTabSz="9143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05" algn="l" defTabSz="9143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882" algn="l" defTabSz="9143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57" algn="l" defTabSz="9143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32" algn="l" defTabSz="9143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07" algn="l" defTabSz="914352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3.png"/><Relationship Id="rId21" Type="http://schemas.openxmlformats.org/officeDocument/2006/relationships/image" Target="../media/image19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8.xml"/><Relationship Id="rId6" Type="http://schemas.openxmlformats.org/officeDocument/2006/relationships/image" Target="../media/image5.png"/><Relationship Id="rId11" Type="http://schemas.openxmlformats.org/officeDocument/2006/relationships/image" Target="../media/image9.tiff"/><Relationship Id="rId24" Type="http://schemas.openxmlformats.org/officeDocument/2006/relationships/image" Target="../media/image22.png"/><Relationship Id="rId5" Type="http://schemas.openxmlformats.org/officeDocument/2006/relationships/chart" Target="../charts/chart1.xml"/><Relationship Id="rId15" Type="http://schemas.openxmlformats.org/officeDocument/2006/relationships/image" Target="../media/image13.tiff"/><Relationship Id="rId23" Type="http://schemas.openxmlformats.org/officeDocument/2006/relationships/image" Target="../media/image21.tiff"/><Relationship Id="rId10" Type="http://schemas.openxmlformats.org/officeDocument/2006/relationships/image" Target="../media/image8.tiff"/><Relationship Id="rId19" Type="http://schemas.openxmlformats.org/officeDocument/2006/relationships/image" Target="../media/image17.png"/><Relationship Id="rId4" Type="http://schemas.openxmlformats.org/officeDocument/2006/relationships/image" Target="../media/image4.png"/><Relationship Id="rId9" Type="http://schemas.openxmlformats.org/officeDocument/2006/relationships/chart" Target="../charts/chart2.xml"/><Relationship Id="rId14" Type="http://schemas.openxmlformats.org/officeDocument/2006/relationships/image" Target="../media/image12.png"/><Relationship Id="rId22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rot="5400000">
            <a:off x="2123468" y="1606032"/>
            <a:ext cx="990902" cy="1377817"/>
          </a:xfrm>
          <a:prstGeom prst="rect">
            <a:avLst/>
          </a:prstGeom>
        </p:spPr>
      </p:pic>
      <p:pic>
        <p:nvPicPr>
          <p:cNvPr id="176" name="Picture 17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-560"/>
          <a:stretch/>
        </p:blipFill>
        <p:spPr>
          <a:xfrm rot="5400000">
            <a:off x="2819537" y="1502159"/>
            <a:ext cx="187444" cy="776505"/>
          </a:xfrm>
          <a:prstGeom prst="rect">
            <a:avLst/>
          </a:prstGeom>
        </p:spPr>
      </p:pic>
      <p:graphicFrame>
        <p:nvGraphicFramePr>
          <p:cNvPr id="162" name="Chart 1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0277169"/>
              </p:ext>
            </p:extLst>
          </p:nvPr>
        </p:nvGraphicFramePr>
        <p:xfrm>
          <a:off x="7202823" y="3421110"/>
          <a:ext cx="5041451" cy="27142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28792" y="4040948"/>
            <a:ext cx="1365622" cy="96934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83848" y="1823756"/>
            <a:ext cx="1353429" cy="993734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V="1">
            <a:off x="1924302" y="2946855"/>
            <a:ext cx="1368631" cy="972408"/>
          </a:xfrm>
          <a:prstGeom prst="rect">
            <a:avLst/>
          </a:prstGeom>
        </p:spPr>
      </p:pic>
      <p:graphicFrame>
        <p:nvGraphicFramePr>
          <p:cNvPr id="175" name="Chart 17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3198199"/>
              </p:ext>
            </p:extLst>
          </p:nvPr>
        </p:nvGraphicFramePr>
        <p:xfrm>
          <a:off x="7083704" y="161864"/>
          <a:ext cx="5136275" cy="27084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pic>
        <p:nvPicPr>
          <p:cNvPr id="135" name="Picture 134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V="1">
            <a:off x="4479388" y="5179912"/>
            <a:ext cx="1378434" cy="979225"/>
          </a:xfrm>
          <a:prstGeom prst="rect">
            <a:avLst/>
          </a:prstGeom>
        </p:spPr>
      </p:pic>
      <p:pic>
        <p:nvPicPr>
          <p:cNvPr id="137" name="Picture 136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V="1">
            <a:off x="5069984" y="5184565"/>
            <a:ext cx="780367" cy="196521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V="1">
            <a:off x="1917690" y="5186567"/>
            <a:ext cx="1367392" cy="988584"/>
          </a:xfrm>
          <a:prstGeom prst="rect">
            <a:avLst/>
          </a:prstGeom>
        </p:spPr>
      </p:pic>
      <p:pic>
        <p:nvPicPr>
          <p:cNvPr id="132" name="Picture 131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V="1">
            <a:off x="2502104" y="5178978"/>
            <a:ext cx="780402" cy="203588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V="1">
            <a:off x="4481481" y="4074594"/>
            <a:ext cx="1385484" cy="969263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481481" y="2990854"/>
            <a:ext cx="1391487" cy="982233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496631" y="617873"/>
            <a:ext cx="1361189" cy="98755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V="1">
            <a:off x="1925040" y="632876"/>
            <a:ext cx="1390749" cy="999981"/>
          </a:xfrm>
          <a:prstGeom prst="rect">
            <a:avLst/>
          </a:prstGeom>
        </p:spPr>
      </p:pic>
      <p:sp>
        <p:nvSpPr>
          <p:cNvPr id="12" name="Title 1">
            <a:extLst>
              <a:ext uri="{FF2B5EF4-FFF2-40B4-BE49-F238E27FC236}">
                <a16:creationId xmlns:a16="http://schemas.microsoft.com/office/drawing/2014/main" xmlns="" id="{2F2E2F2D-F5EE-412D-A89A-5FD569FD42B3}"/>
              </a:ext>
            </a:extLst>
          </p:cNvPr>
          <p:cNvSpPr txBox="1">
            <a:spLocks/>
          </p:cNvSpPr>
          <p:nvPr/>
        </p:nvSpPr>
        <p:spPr>
          <a:xfrm>
            <a:off x="1950132" y="241705"/>
            <a:ext cx="1156503" cy="37382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month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xmlns="" id="{2F2E2F2D-F5EE-412D-A89A-5FD569FD42B3}"/>
              </a:ext>
            </a:extLst>
          </p:cNvPr>
          <p:cNvSpPr txBox="1">
            <a:spLocks/>
          </p:cNvSpPr>
          <p:nvPr/>
        </p:nvSpPr>
        <p:spPr>
          <a:xfrm>
            <a:off x="4489445" y="241705"/>
            <a:ext cx="1156503" cy="37382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</a:p>
        </p:txBody>
      </p:sp>
      <p:sp>
        <p:nvSpPr>
          <p:cNvPr id="26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56140" y="1441966"/>
            <a:ext cx="507447" cy="18531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P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1839661" y="1758904"/>
            <a:ext cx="567544" cy="110189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CA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A</a:t>
            </a:r>
            <a:endParaRPr 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1834949" y="2928352"/>
            <a:ext cx="567544" cy="110189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CA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A</a:t>
            </a:r>
            <a:endParaRPr 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4407798" y="2962561"/>
            <a:ext cx="567544" cy="110189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CA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A</a:t>
            </a:r>
            <a:endParaRPr 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1845744" y="4018961"/>
            <a:ext cx="567544" cy="141372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CA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A</a:t>
            </a:r>
            <a:endParaRPr 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4393617" y="4032840"/>
            <a:ext cx="567544" cy="110189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CA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A</a:t>
            </a:r>
            <a:endParaRPr 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1857919" y="5151309"/>
            <a:ext cx="567544" cy="128995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CA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A</a:t>
            </a:r>
            <a:endParaRPr 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4389693" y="5137878"/>
            <a:ext cx="567544" cy="110189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CA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A</a:t>
            </a:r>
            <a:endParaRPr 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itle 1">
            <a:extLst>
              <a:ext uri="{FF2B5EF4-FFF2-40B4-BE49-F238E27FC236}">
                <a16:creationId xmlns:a16="http://schemas.microsoft.com/office/drawing/2014/main" xmlns="" id="{2F2E2F2D-F5EE-412D-A89A-5FD569FD42B3}"/>
              </a:ext>
            </a:extLst>
          </p:cNvPr>
          <p:cNvSpPr txBox="1">
            <a:spLocks/>
          </p:cNvSpPr>
          <p:nvPr/>
        </p:nvSpPr>
        <p:spPr>
          <a:xfrm>
            <a:off x="935653" y="879136"/>
            <a:ext cx="996391" cy="377259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29S1</a:t>
            </a:r>
          </a:p>
        </p:txBody>
      </p:sp>
      <p:sp>
        <p:nvSpPr>
          <p:cNvPr id="44" name="Title 1">
            <a:extLst>
              <a:ext uri="{FF2B5EF4-FFF2-40B4-BE49-F238E27FC236}">
                <a16:creationId xmlns:a16="http://schemas.microsoft.com/office/drawing/2014/main" xmlns="" id="{2F2E2F2D-F5EE-412D-A89A-5FD569FD42B3}"/>
              </a:ext>
            </a:extLst>
          </p:cNvPr>
          <p:cNvSpPr txBox="1">
            <a:spLocks/>
          </p:cNvSpPr>
          <p:nvPr/>
        </p:nvSpPr>
        <p:spPr>
          <a:xfrm>
            <a:off x="97466" y="2053761"/>
            <a:ext cx="1842867" cy="33764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bca4</a:t>
            </a:r>
            <a:r>
              <a:rPr lang="en-US" sz="12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2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Isosceles Triangle 51"/>
          <p:cNvSpPr/>
          <p:nvPr/>
        </p:nvSpPr>
        <p:spPr>
          <a:xfrm rot="19739791">
            <a:off x="3060930" y="3870011"/>
            <a:ext cx="45719" cy="50208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Isosceles Triangle 53"/>
          <p:cNvSpPr/>
          <p:nvPr/>
        </p:nvSpPr>
        <p:spPr>
          <a:xfrm>
            <a:off x="5137990" y="3062947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Isosceles Triangle 54"/>
          <p:cNvSpPr/>
          <p:nvPr/>
        </p:nvSpPr>
        <p:spPr>
          <a:xfrm>
            <a:off x="5349986" y="3066972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Isosceles Triangle 55"/>
          <p:cNvSpPr/>
          <p:nvPr/>
        </p:nvSpPr>
        <p:spPr>
          <a:xfrm>
            <a:off x="2233567" y="4949920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1858215" y="596654"/>
            <a:ext cx="567544" cy="110189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CA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A</a:t>
            </a:r>
            <a:endParaRPr 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Isosceles Triangle 58"/>
          <p:cNvSpPr/>
          <p:nvPr/>
        </p:nvSpPr>
        <p:spPr>
          <a:xfrm>
            <a:off x="5151363" y="4983131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Isosceles Triangle 59"/>
          <p:cNvSpPr/>
          <p:nvPr/>
        </p:nvSpPr>
        <p:spPr>
          <a:xfrm>
            <a:off x="5723313" y="3933931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Isosceles Triangle 60"/>
          <p:cNvSpPr/>
          <p:nvPr/>
        </p:nvSpPr>
        <p:spPr>
          <a:xfrm>
            <a:off x="2632306" y="5284175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Isosceles Triangle 62"/>
          <p:cNvSpPr/>
          <p:nvPr/>
        </p:nvSpPr>
        <p:spPr>
          <a:xfrm>
            <a:off x="5769032" y="6044195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Isosceles Triangle 63"/>
          <p:cNvSpPr/>
          <p:nvPr/>
        </p:nvSpPr>
        <p:spPr>
          <a:xfrm>
            <a:off x="5691143" y="5263721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164126" y="6418498"/>
            <a:ext cx="888892" cy="202195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 µm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59203" y="964034"/>
            <a:ext cx="458711" cy="22484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</a:p>
        </p:txBody>
      </p:sp>
      <p:sp>
        <p:nvSpPr>
          <p:cNvPr id="70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70305" y="1297083"/>
            <a:ext cx="537691" cy="144883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S/OS</a:t>
            </a:r>
          </a:p>
        </p:txBody>
      </p:sp>
      <p:sp>
        <p:nvSpPr>
          <p:cNvPr id="72" name="Isosceles Triangle 71"/>
          <p:cNvSpPr/>
          <p:nvPr/>
        </p:nvSpPr>
        <p:spPr>
          <a:xfrm>
            <a:off x="3033975" y="693945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Isosceles Triangle 72"/>
          <p:cNvSpPr/>
          <p:nvPr/>
        </p:nvSpPr>
        <p:spPr>
          <a:xfrm>
            <a:off x="3224586" y="693944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Straight Connector 64"/>
          <p:cNvCxnSpPr/>
          <p:nvPr/>
        </p:nvCxnSpPr>
        <p:spPr>
          <a:xfrm>
            <a:off x="5418408" y="6374234"/>
            <a:ext cx="432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7" t="1" b="-1"/>
          <a:stretch/>
        </p:blipFill>
        <p:spPr>
          <a:xfrm>
            <a:off x="2523103" y="637175"/>
            <a:ext cx="788827" cy="185987"/>
          </a:xfrm>
          <a:prstGeom prst="rect">
            <a:avLst/>
          </a:prstGeom>
        </p:spPr>
      </p:pic>
      <p:sp>
        <p:nvSpPr>
          <p:cNvPr id="84" name="Rectangle 83"/>
          <p:cNvSpPr/>
          <p:nvPr/>
        </p:nvSpPr>
        <p:spPr>
          <a:xfrm>
            <a:off x="2526612" y="629950"/>
            <a:ext cx="785553" cy="19614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Isosceles Triangle 85"/>
          <p:cNvSpPr/>
          <p:nvPr/>
        </p:nvSpPr>
        <p:spPr>
          <a:xfrm rot="2235581">
            <a:off x="3145888" y="1490355"/>
            <a:ext cx="45719" cy="51436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Isosceles Triangle 86"/>
          <p:cNvSpPr/>
          <p:nvPr/>
        </p:nvSpPr>
        <p:spPr>
          <a:xfrm rot="2235581">
            <a:off x="3090599" y="746961"/>
            <a:ext cx="45719" cy="51436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Isosceles Triangle 89"/>
          <p:cNvSpPr/>
          <p:nvPr/>
        </p:nvSpPr>
        <p:spPr>
          <a:xfrm rot="2235581">
            <a:off x="4952482" y="1567538"/>
            <a:ext cx="45719" cy="51436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Isosceles Triangle 90"/>
          <p:cNvSpPr/>
          <p:nvPr/>
        </p:nvSpPr>
        <p:spPr>
          <a:xfrm rot="2235581">
            <a:off x="5457347" y="734455"/>
            <a:ext cx="45719" cy="51436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4393617" y="581480"/>
            <a:ext cx="567544" cy="110189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CA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A</a:t>
            </a:r>
            <a:endParaRPr 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3" name="Picture 92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072398" y="618381"/>
            <a:ext cx="779172" cy="190871"/>
          </a:xfrm>
          <a:prstGeom prst="rect">
            <a:avLst/>
          </a:prstGeom>
        </p:spPr>
      </p:pic>
      <p:sp>
        <p:nvSpPr>
          <p:cNvPr id="88" name="Rectangle 87"/>
          <p:cNvSpPr/>
          <p:nvPr/>
        </p:nvSpPr>
        <p:spPr>
          <a:xfrm>
            <a:off x="5066530" y="617426"/>
            <a:ext cx="785553" cy="19614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Isosceles Triangle 93"/>
          <p:cNvSpPr/>
          <p:nvPr/>
        </p:nvSpPr>
        <p:spPr>
          <a:xfrm rot="2235581">
            <a:off x="5315405" y="693705"/>
            <a:ext cx="45719" cy="51436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ectangle 95"/>
          <p:cNvSpPr/>
          <p:nvPr/>
        </p:nvSpPr>
        <p:spPr>
          <a:xfrm>
            <a:off x="2523249" y="1796058"/>
            <a:ext cx="785553" cy="19614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5" name="Group 104"/>
          <p:cNvGrpSpPr/>
          <p:nvPr/>
        </p:nvGrpSpPr>
        <p:grpSpPr>
          <a:xfrm rot="2377336">
            <a:off x="2963081" y="1883141"/>
            <a:ext cx="54467" cy="67186"/>
            <a:chOff x="2443301" y="2235306"/>
            <a:chExt cx="97316" cy="118994"/>
          </a:xfrm>
        </p:grpSpPr>
        <p:cxnSp>
          <p:nvCxnSpPr>
            <p:cNvPr id="106" name="Straight Connector 105"/>
            <p:cNvCxnSpPr/>
            <p:nvPr/>
          </p:nvCxnSpPr>
          <p:spPr>
            <a:xfrm flipH="1" flipV="1">
              <a:off x="2489761" y="2235307"/>
              <a:ext cx="50856" cy="118993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/>
            <p:cNvCxnSpPr/>
            <p:nvPr/>
          </p:nvCxnSpPr>
          <p:spPr>
            <a:xfrm flipV="1">
              <a:off x="2443301" y="2235306"/>
              <a:ext cx="50856" cy="118993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8" name="Group 107"/>
          <p:cNvGrpSpPr/>
          <p:nvPr/>
        </p:nvGrpSpPr>
        <p:grpSpPr>
          <a:xfrm rot="2377336">
            <a:off x="2266110" y="2731219"/>
            <a:ext cx="54467" cy="67186"/>
            <a:chOff x="2443301" y="2235306"/>
            <a:chExt cx="97316" cy="118994"/>
          </a:xfrm>
        </p:grpSpPr>
        <p:cxnSp>
          <p:nvCxnSpPr>
            <p:cNvPr id="109" name="Straight Connector 108"/>
            <p:cNvCxnSpPr/>
            <p:nvPr/>
          </p:nvCxnSpPr>
          <p:spPr>
            <a:xfrm flipH="1" flipV="1">
              <a:off x="2489761" y="2235307"/>
              <a:ext cx="50856" cy="118993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/>
            <p:cNvCxnSpPr/>
            <p:nvPr/>
          </p:nvCxnSpPr>
          <p:spPr>
            <a:xfrm flipV="1">
              <a:off x="2443301" y="2235306"/>
              <a:ext cx="50856" cy="118993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2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4400242" y="1809594"/>
            <a:ext cx="567544" cy="110189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CA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ORA</a:t>
            </a:r>
            <a:endParaRPr lang="en-US" sz="10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3" name="Picture 112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V="1">
            <a:off x="5056834" y="1827368"/>
            <a:ext cx="777846" cy="193737"/>
          </a:xfrm>
          <a:prstGeom prst="rect">
            <a:avLst/>
          </a:prstGeom>
        </p:spPr>
      </p:pic>
      <p:sp>
        <p:nvSpPr>
          <p:cNvPr id="114" name="Rectangle 113"/>
          <p:cNvSpPr/>
          <p:nvPr/>
        </p:nvSpPr>
        <p:spPr>
          <a:xfrm>
            <a:off x="5053665" y="1823522"/>
            <a:ext cx="785553" cy="19614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5" name="Group 114"/>
          <p:cNvGrpSpPr/>
          <p:nvPr/>
        </p:nvGrpSpPr>
        <p:grpSpPr>
          <a:xfrm rot="19222664" flipH="1">
            <a:off x="5738482" y="2723567"/>
            <a:ext cx="54467" cy="67186"/>
            <a:chOff x="2443301" y="2235306"/>
            <a:chExt cx="97316" cy="118994"/>
          </a:xfrm>
        </p:grpSpPr>
        <p:cxnSp>
          <p:nvCxnSpPr>
            <p:cNvPr id="116" name="Straight Connector 115"/>
            <p:cNvCxnSpPr/>
            <p:nvPr/>
          </p:nvCxnSpPr>
          <p:spPr>
            <a:xfrm flipH="1" flipV="1">
              <a:off x="2489761" y="2235307"/>
              <a:ext cx="50856" cy="118993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 flipV="1">
              <a:off x="2443301" y="2235306"/>
              <a:ext cx="50856" cy="118993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8" name="Group 117"/>
          <p:cNvGrpSpPr/>
          <p:nvPr/>
        </p:nvGrpSpPr>
        <p:grpSpPr>
          <a:xfrm rot="19222664" flipH="1">
            <a:off x="5673708" y="1953044"/>
            <a:ext cx="54467" cy="67186"/>
            <a:chOff x="2443301" y="2235306"/>
            <a:chExt cx="97316" cy="118994"/>
          </a:xfrm>
        </p:grpSpPr>
        <p:cxnSp>
          <p:nvCxnSpPr>
            <p:cNvPr id="119" name="Straight Connector 118"/>
            <p:cNvCxnSpPr/>
            <p:nvPr/>
          </p:nvCxnSpPr>
          <p:spPr>
            <a:xfrm flipH="1" flipV="1">
              <a:off x="2489761" y="2235307"/>
              <a:ext cx="50856" cy="118993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19"/>
            <p:cNvCxnSpPr/>
            <p:nvPr/>
          </p:nvCxnSpPr>
          <p:spPr>
            <a:xfrm flipV="1">
              <a:off x="2443301" y="2235306"/>
              <a:ext cx="50856" cy="118993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21" name="Picture 120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V="1">
            <a:off x="2504510" y="2949354"/>
            <a:ext cx="783442" cy="194256"/>
          </a:xfrm>
          <a:prstGeom prst="rect">
            <a:avLst/>
          </a:prstGeom>
        </p:spPr>
      </p:pic>
      <p:sp>
        <p:nvSpPr>
          <p:cNvPr id="122" name="Rectangle 121"/>
          <p:cNvSpPr/>
          <p:nvPr/>
        </p:nvSpPr>
        <p:spPr>
          <a:xfrm>
            <a:off x="2509870" y="2950378"/>
            <a:ext cx="785553" cy="19614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Isosceles Triangle 122"/>
          <p:cNvSpPr/>
          <p:nvPr/>
        </p:nvSpPr>
        <p:spPr>
          <a:xfrm rot="19739791">
            <a:off x="3048052" y="3055935"/>
            <a:ext cx="45719" cy="50208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5" name="Picture 124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086257" y="2990600"/>
            <a:ext cx="780708" cy="185447"/>
          </a:xfrm>
          <a:prstGeom prst="rect">
            <a:avLst/>
          </a:prstGeom>
        </p:spPr>
      </p:pic>
      <p:sp>
        <p:nvSpPr>
          <p:cNvPr id="124" name="Rectangle 123"/>
          <p:cNvSpPr/>
          <p:nvPr/>
        </p:nvSpPr>
        <p:spPr>
          <a:xfrm>
            <a:off x="5083543" y="2983447"/>
            <a:ext cx="785553" cy="19614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Isosceles Triangle 125"/>
          <p:cNvSpPr/>
          <p:nvPr/>
        </p:nvSpPr>
        <p:spPr>
          <a:xfrm>
            <a:off x="5539122" y="3085327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7" name="Picture 126"/>
          <p:cNvPicPr>
            <a:picLocks noChangeAspect="1"/>
          </p:cNvPicPr>
          <p:nvPr/>
        </p:nvPicPr>
        <p:blipFill rotWithShape="1"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080"/>
          <a:stretch/>
        </p:blipFill>
        <p:spPr>
          <a:xfrm flipV="1">
            <a:off x="2498780" y="4036315"/>
            <a:ext cx="789596" cy="199122"/>
          </a:xfrm>
          <a:prstGeom prst="rect">
            <a:avLst/>
          </a:prstGeom>
        </p:spPr>
      </p:pic>
      <p:sp>
        <p:nvSpPr>
          <p:cNvPr id="128" name="Rectangle 127"/>
          <p:cNvSpPr/>
          <p:nvPr/>
        </p:nvSpPr>
        <p:spPr>
          <a:xfrm>
            <a:off x="2503997" y="4038911"/>
            <a:ext cx="785553" cy="19614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0" name="Picture 129"/>
          <p:cNvPicPr>
            <a:picLocks noChangeAspect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3249" b="-1"/>
          <a:stretch/>
        </p:blipFill>
        <p:spPr>
          <a:xfrm flipV="1">
            <a:off x="5079125" y="4083323"/>
            <a:ext cx="793028" cy="183095"/>
          </a:xfrm>
          <a:prstGeom prst="rect">
            <a:avLst/>
          </a:prstGeom>
        </p:spPr>
      </p:pic>
      <p:sp>
        <p:nvSpPr>
          <p:cNvPr id="129" name="Rectangle 128"/>
          <p:cNvSpPr/>
          <p:nvPr/>
        </p:nvSpPr>
        <p:spPr>
          <a:xfrm>
            <a:off x="5082603" y="4076175"/>
            <a:ext cx="785553" cy="19614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Isosceles Triangle 130"/>
          <p:cNvSpPr/>
          <p:nvPr/>
        </p:nvSpPr>
        <p:spPr>
          <a:xfrm>
            <a:off x="5395705" y="4216365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Rectangle 132"/>
          <p:cNvSpPr/>
          <p:nvPr/>
        </p:nvSpPr>
        <p:spPr>
          <a:xfrm>
            <a:off x="2496953" y="5179660"/>
            <a:ext cx="785553" cy="19614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Isosceles Triangle 133"/>
          <p:cNvSpPr/>
          <p:nvPr/>
        </p:nvSpPr>
        <p:spPr>
          <a:xfrm>
            <a:off x="2757775" y="6079187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Rectangle 135"/>
          <p:cNvSpPr/>
          <p:nvPr/>
        </p:nvSpPr>
        <p:spPr>
          <a:xfrm>
            <a:off x="5068857" y="5180250"/>
            <a:ext cx="785553" cy="19614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792248" y="1426275"/>
            <a:ext cx="526148" cy="169914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P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803026" y="672137"/>
            <a:ext cx="458711" cy="22484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</a:p>
        </p:txBody>
      </p:sp>
      <p:sp>
        <p:nvSpPr>
          <p:cNvPr id="99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800530" y="804019"/>
            <a:ext cx="537691" cy="144883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S/OS</a:t>
            </a:r>
          </a:p>
        </p:txBody>
      </p:sp>
      <p:sp>
        <p:nvSpPr>
          <p:cNvPr id="100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49728" y="2627421"/>
            <a:ext cx="487474" cy="216696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P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50155" y="2060029"/>
            <a:ext cx="458711" cy="22484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</a:p>
        </p:txBody>
      </p:sp>
      <p:sp>
        <p:nvSpPr>
          <p:cNvPr id="102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61257" y="2393078"/>
            <a:ext cx="537691" cy="144883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S/OS</a:t>
            </a:r>
          </a:p>
        </p:txBody>
      </p:sp>
      <p:sp>
        <p:nvSpPr>
          <p:cNvPr id="103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794479" y="2563766"/>
            <a:ext cx="484118" cy="175277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P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794480" y="2055205"/>
            <a:ext cx="458711" cy="22484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</a:p>
        </p:txBody>
      </p:sp>
      <p:sp>
        <p:nvSpPr>
          <p:cNvPr id="111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794529" y="2346788"/>
            <a:ext cx="537691" cy="144883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S/OS</a:t>
            </a:r>
          </a:p>
        </p:txBody>
      </p:sp>
      <p:sp>
        <p:nvSpPr>
          <p:cNvPr id="138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24586" y="3627364"/>
            <a:ext cx="507989" cy="222526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P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46316" y="3060785"/>
            <a:ext cx="458711" cy="22484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</a:p>
        </p:txBody>
      </p:sp>
      <p:sp>
        <p:nvSpPr>
          <p:cNvPr id="140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57418" y="3393834"/>
            <a:ext cx="537691" cy="144883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S/OS</a:t>
            </a:r>
          </a:p>
        </p:txBody>
      </p:sp>
      <p:sp>
        <p:nvSpPr>
          <p:cNvPr id="141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817339" y="3783677"/>
            <a:ext cx="500240" cy="189045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P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828934" y="3169992"/>
            <a:ext cx="458711" cy="22484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</a:p>
        </p:txBody>
      </p:sp>
      <p:sp>
        <p:nvSpPr>
          <p:cNvPr id="143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840036" y="3503041"/>
            <a:ext cx="537691" cy="144883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S/OS</a:t>
            </a:r>
          </a:p>
        </p:txBody>
      </p:sp>
      <p:sp>
        <p:nvSpPr>
          <p:cNvPr id="144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32385" y="4750254"/>
            <a:ext cx="509363" cy="208473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P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45177" y="4272322"/>
            <a:ext cx="458711" cy="22484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</a:p>
        </p:txBody>
      </p:sp>
      <p:sp>
        <p:nvSpPr>
          <p:cNvPr id="146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47231" y="4544490"/>
            <a:ext cx="537691" cy="144883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S/OS</a:t>
            </a:r>
          </a:p>
        </p:txBody>
      </p:sp>
      <p:sp>
        <p:nvSpPr>
          <p:cNvPr id="147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822283" y="4860932"/>
            <a:ext cx="470301" cy="185939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P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834020" y="4364736"/>
            <a:ext cx="458711" cy="22484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</a:p>
        </p:txBody>
      </p:sp>
      <p:sp>
        <p:nvSpPr>
          <p:cNvPr id="149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827439" y="4609942"/>
            <a:ext cx="537691" cy="144883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S/OS</a:t>
            </a:r>
          </a:p>
        </p:txBody>
      </p:sp>
      <p:sp>
        <p:nvSpPr>
          <p:cNvPr id="150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36003" y="5898916"/>
            <a:ext cx="496572" cy="209165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P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36129" y="5420984"/>
            <a:ext cx="458711" cy="22484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</a:p>
        </p:txBody>
      </p:sp>
      <p:sp>
        <p:nvSpPr>
          <p:cNvPr id="152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3238006" y="5642212"/>
            <a:ext cx="537691" cy="144883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S/OS</a:t>
            </a:r>
          </a:p>
        </p:txBody>
      </p:sp>
      <p:sp>
        <p:nvSpPr>
          <p:cNvPr id="153" name="Title 1">
            <a:extLst>
              <a:ext uri="{FF2B5EF4-FFF2-40B4-BE49-F238E27FC236}">
                <a16:creationId xmlns:a16="http://schemas.microsoft.com/office/drawing/2014/main" xmlns="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794479" y="5962727"/>
            <a:ext cx="484118" cy="183417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PE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803026" y="5591058"/>
            <a:ext cx="458711" cy="22484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NL</a:t>
            </a:r>
          </a:p>
        </p:txBody>
      </p:sp>
      <p:sp>
        <p:nvSpPr>
          <p:cNvPr id="155" name="Title 1">
            <a:extLst>
              <a:ext uri="{FF2B5EF4-FFF2-40B4-BE49-F238E27FC236}">
                <a16:creationId xmlns="" xmlns:a16="http://schemas.microsoft.com/office/drawing/2014/main" id="{8F0BB9A7-94B2-48D2-8E66-DF3A79BD6BFF}"/>
              </a:ext>
            </a:extLst>
          </p:cNvPr>
          <p:cNvSpPr txBox="1">
            <a:spLocks/>
          </p:cNvSpPr>
          <p:nvPr/>
        </p:nvSpPr>
        <p:spPr>
          <a:xfrm>
            <a:off x="5803026" y="5810710"/>
            <a:ext cx="537691" cy="144883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S/OS</a:t>
            </a:r>
          </a:p>
        </p:txBody>
      </p:sp>
      <p:sp>
        <p:nvSpPr>
          <p:cNvPr id="156" name="Title 1">
            <a:extLst>
              <a:ext uri="{FF2B5EF4-FFF2-40B4-BE49-F238E27FC236}">
                <a16:creationId xmlns="" xmlns:a16="http://schemas.microsoft.com/office/drawing/2014/main" id="{2F2E2F2D-F5EE-412D-A89A-5FD569FD42B3}"/>
              </a:ext>
            </a:extLst>
          </p:cNvPr>
          <p:cNvSpPr txBox="1">
            <a:spLocks/>
          </p:cNvSpPr>
          <p:nvPr/>
        </p:nvSpPr>
        <p:spPr>
          <a:xfrm>
            <a:off x="23933" y="3281945"/>
            <a:ext cx="1925653" cy="358826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AV5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-hRORA 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ow Dose Treated</a:t>
            </a:r>
          </a:p>
        </p:txBody>
      </p:sp>
      <p:sp>
        <p:nvSpPr>
          <p:cNvPr id="157" name="Title 1">
            <a:extLst>
              <a:ext uri="{FF2B5EF4-FFF2-40B4-BE49-F238E27FC236}">
                <a16:creationId xmlns="" xmlns:a16="http://schemas.microsoft.com/office/drawing/2014/main" id="{2F2E2F2D-F5EE-412D-A89A-5FD569FD42B3}"/>
              </a:ext>
            </a:extLst>
          </p:cNvPr>
          <p:cNvSpPr txBox="1">
            <a:spLocks/>
          </p:cNvSpPr>
          <p:nvPr/>
        </p:nvSpPr>
        <p:spPr>
          <a:xfrm>
            <a:off x="1574" y="4464130"/>
            <a:ext cx="1940666" cy="37853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AV5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-hRORA 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d Dose Treated</a:t>
            </a:r>
          </a:p>
        </p:txBody>
      </p:sp>
      <p:sp>
        <p:nvSpPr>
          <p:cNvPr id="158" name="Title 1">
            <a:extLst>
              <a:ext uri="{FF2B5EF4-FFF2-40B4-BE49-F238E27FC236}">
                <a16:creationId xmlns="" xmlns:a16="http://schemas.microsoft.com/office/drawing/2014/main" id="{2F2E2F2D-F5EE-412D-A89A-5FD569FD42B3}"/>
              </a:ext>
            </a:extLst>
          </p:cNvPr>
          <p:cNvSpPr txBox="1">
            <a:spLocks/>
          </p:cNvSpPr>
          <p:nvPr/>
        </p:nvSpPr>
        <p:spPr>
          <a:xfrm>
            <a:off x="47124" y="5632983"/>
            <a:ext cx="1908946" cy="29318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AV5-h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ORA 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igh Dose Treated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xmlns="" id="{1634E2BC-C8E7-4A38-A704-98D7CC3AD955}"/>
              </a:ext>
            </a:extLst>
          </p:cNvPr>
          <p:cNvSpPr txBox="1"/>
          <p:nvPr/>
        </p:nvSpPr>
        <p:spPr>
          <a:xfrm>
            <a:off x="0" y="157402"/>
            <a:ext cx="5103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xmlns="" id="{1634E2BC-C8E7-4A38-A704-98D7CC3AD955}"/>
              </a:ext>
            </a:extLst>
          </p:cNvPr>
          <p:cNvSpPr txBox="1"/>
          <p:nvPr/>
        </p:nvSpPr>
        <p:spPr>
          <a:xfrm>
            <a:off x="7032172" y="161864"/>
            <a:ext cx="51039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9323155" y="878135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=0.000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9772894" y="876193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00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10234150" y="804835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00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10634714" y="1124044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=0.0115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11089594" y="705733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00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11544474" y="646010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00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9848408" y="4224493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=0.000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9393153" y="4272322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=0.0027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10288466" y="4056878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&lt;0.000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10743346" y="4286649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=0.003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11143910" y="4138328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=0.001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11621143" y="4062771"/>
            <a:ext cx="8011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CA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=0.000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Isosceles Triangle 160"/>
          <p:cNvSpPr/>
          <p:nvPr/>
        </p:nvSpPr>
        <p:spPr>
          <a:xfrm>
            <a:off x="2712056" y="4158264"/>
            <a:ext cx="45719" cy="6622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2465506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DateofMeeting xmlns="d1a4ea98-21f4-41d4-8b7f-2ac246d68a29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8E67CB1291B904B99BD99EE141FADD4" ma:contentTypeVersion="12" ma:contentTypeDescription="Create a new document." ma:contentTypeScope="" ma:versionID="2933b01aeeb024c1169cd2c934befb27">
  <xsd:schema xmlns:xsd="http://www.w3.org/2001/XMLSchema" xmlns:xs="http://www.w3.org/2001/XMLSchema" xmlns:p="http://schemas.microsoft.com/office/2006/metadata/properties" xmlns:ns2="d1a4ea98-21f4-41d4-8b7f-2ac246d68a29" xmlns:ns3="9c63696c-1466-4ae6-af0c-2404752829f1" targetNamespace="http://schemas.microsoft.com/office/2006/metadata/properties" ma:root="true" ma:fieldsID="9daeb6a20736b0006aad0f940accff4e" ns2:_="" ns3:_="">
    <xsd:import namespace="d1a4ea98-21f4-41d4-8b7f-2ac246d68a29"/>
    <xsd:import namespace="9c63696c-1466-4ae6-af0c-2404752829f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DateofMeeting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1a4ea98-21f4-41d4-8b7f-2ac246d68a2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DateofMeeting" ma:index="12" nillable="true" ma:displayName="Date of Meeting" ma:format="DateOnly" ma:internalName="DateofMeeting">
      <xsd:simpleType>
        <xsd:restriction base="dms:DateTime"/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c63696c-1466-4ae6-af0c-2404752829f1" elementFormDefault="qualified">
    <xsd:import namespace="http://schemas.microsoft.com/office/2006/documentManagement/types"/>
    <xsd:import namespace="http://schemas.microsoft.com/office/infopath/2007/PartnerControls"/>
    <xsd:element name="SharedWithUsers" ma:index="13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4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9C581F8-4847-44D8-A9EF-5699C754E1CD}">
  <ds:schemaRefs>
    <ds:schemaRef ds:uri="http://schemas.microsoft.com/office/2006/documentManagement/types"/>
    <ds:schemaRef ds:uri="http://schemas.openxmlformats.org/package/2006/metadata/core-properties"/>
    <ds:schemaRef ds:uri="http://www.w3.org/XML/1998/namespace"/>
    <ds:schemaRef ds:uri="http://schemas.microsoft.com/office/infopath/2007/PartnerControls"/>
    <ds:schemaRef ds:uri="http://schemas.microsoft.com/office/2006/metadata/properties"/>
    <ds:schemaRef ds:uri="http://purl.org/dc/terms/"/>
    <ds:schemaRef ds:uri="http://purl.org/dc/elements/1.1/"/>
    <ds:schemaRef ds:uri="9c63696c-1466-4ae6-af0c-2404752829f1"/>
    <ds:schemaRef ds:uri="d1a4ea98-21f4-41d4-8b7f-2ac246d68a29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94A3B741-DAEE-4FF8-8AB1-C7B8A1D38C7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1a4ea98-21f4-41d4-8b7f-2ac246d68a29"/>
    <ds:schemaRef ds:uri="9c63696c-1466-4ae6-af0c-2404752829f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E8191B7E-AECA-4C48-9001-0A7A2F7DB35F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748</TotalTime>
  <Words>112</Words>
  <Application>Microsoft Office PowerPoint</Application>
  <PresentationFormat>Widescreen</PresentationFormat>
  <Paragraphs>7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1_Office Theme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lina Drag</dc:creator>
  <cp:lastModifiedBy>MA</cp:lastModifiedBy>
  <cp:revision>751</cp:revision>
  <dcterms:created xsi:type="dcterms:W3CDTF">2021-09-08T14:52:40Z</dcterms:created>
  <dcterms:modified xsi:type="dcterms:W3CDTF">2024-05-01T14:39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8E67CB1291B904B99BD99EE141FADD4</vt:lpwstr>
  </property>
</Properties>
</file>